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A6FF4-09A0-4336-927C-F650E75473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2BD98-9B49-413A-B8E5-30EB5CD34F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3608D-E29C-446D-AFE8-0AC33F91FD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A5FA3-20DF-4A77-8D2D-6EE1EE89D8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1A778-F036-4FD0-9A1D-A8E3F3B2FA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77177-27B4-44BB-81BF-F8C9090CBB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1B640-1659-4ED2-9F2C-2679AC899F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9C2E4-2110-4770-A319-9E2610C61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F9172-2E8F-4716-869D-F402064F1F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7CD11-7C10-44D8-BBB2-3C37B81378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3D54F-0E5D-4D15-8198-0D52A9A959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AAF5A-FB3F-41E1-90DF-DC0D156A30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C41760-4693-4949-B92F-49DE6C44A2D2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228600" y="4724280"/>
            <a:ext cx="8610480" cy="91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upplementary Figure S1 </a:t>
            </a: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Kaplan-Meier analysis of overall survival based on Therapeutic strategies in 156 gastric cancer patient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981080" y="838080"/>
            <a:ext cx="4318200" cy="3735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adminstrator</cp:lastModifiedBy>
  <dcterms:modified xsi:type="dcterms:W3CDTF">2013-06-20T02:39:07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